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7" r:id="rId2"/>
  </p:sldIdLst>
  <p:sldSz cx="7772400" cy="10058400"/>
  <p:notesSz cx="6858000" cy="9144000"/>
  <p:defaultTextStyle>
    <a:defPPr>
      <a:defRPr lang="en-US"/>
    </a:defPPr>
    <a:lvl1pPr marL="0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4521" autoAdjust="0"/>
    <p:restoredTop sz="80441" autoAdjust="0"/>
  </p:normalViewPr>
  <p:slideViewPr>
    <p:cSldViewPr>
      <p:cViewPr varScale="1">
        <p:scale>
          <a:sx n="59" d="100"/>
          <a:sy n="59" d="100"/>
        </p:scale>
        <p:origin x="-2724" y="-78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84" d="100"/>
        <a:sy n="184" d="100"/>
      </p:scale>
      <p:origin x="0" y="-82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31672B-68D1-44C2-95C6-E85C978F2B0D}" type="datetimeFigureOut">
              <a:rPr lang="en-US" smtClean="0"/>
              <a:pPr/>
              <a:t>8/4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57FEC1-8C9C-49DE-A6AF-9DB99DEE027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1200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57FEC1-8C9C-49DE-A6AF-9DB99DEE0270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1791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31"/>
            <a:ext cx="660654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4990" y="402810"/>
            <a:ext cx="1748790" cy="858223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620" y="402810"/>
            <a:ext cx="5116830" cy="858223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4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620" y="2346971"/>
            <a:ext cx="3432810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50970" y="2346971"/>
            <a:ext cx="3432810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3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3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3" y="2251499"/>
            <a:ext cx="3435508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3" y="3189817"/>
            <a:ext cx="3435508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2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7" y="400478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2" y="2104815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3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9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7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55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55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55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6606" y="4262560"/>
            <a:ext cx="6318423" cy="3702297"/>
          </a:xfrm>
          <a:prstGeom prst="rect">
            <a:avLst/>
          </a:prstGeom>
        </p:spPr>
      </p:pic>
      <p:sp>
        <p:nvSpPr>
          <p:cNvPr id="5" name="Rectangle 5"/>
          <p:cNvSpPr>
            <a:spLocks noChangeArrowheads="1"/>
          </p:cNvSpPr>
          <p:nvPr/>
        </p:nvSpPr>
        <p:spPr bwMode="auto">
          <a:xfrm rot="16200000">
            <a:off x="-3828321" y="2749036"/>
            <a:ext cx="891540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800" b="1" dirty="0" smtClean="0">
                <a:latin typeface="Times New Roman" panose="02020603050405020304" pitchFamily="18" charset="0"/>
                <a:ea typeface="SimSun" pitchFamily="2" charset="-122"/>
                <a:cs typeface="Times New Roman" panose="02020603050405020304" pitchFamily="18" charset="0"/>
              </a:rPr>
              <a:t>       CLDN4KD/rescued                     CLDN4KD               2008/SCB</a:t>
            </a:r>
            <a:endParaRPr 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87077" y="167663"/>
            <a:ext cx="10871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lloidin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740948" y="173896"/>
            <a:ext cx="7986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phA2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628351" y="186601"/>
            <a:ext cx="8691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rged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167960" y="6230779"/>
            <a:ext cx="8611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alloidin</a:t>
            </a:r>
            <a:endParaRPr 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276163" y="4326295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phA2</a:t>
            </a:r>
            <a:endParaRPr 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27902" y="4326295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rged</a:t>
            </a:r>
            <a:endParaRPr 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061725" y="6167347"/>
            <a:ext cx="1330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cherry-CLDN4</a:t>
            </a:r>
            <a:endParaRPr 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4101" y="507666"/>
            <a:ext cx="6311951" cy="180062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629" y="2348207"/>
            <a:ext cx="6318423" cy="1874437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267626" y="8004773"/>
            <a:ext cx="7207898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Knockdown 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CLDN4 alters </a:t>
            </a:r>
            <a:r>
              <a:rPr lang="en-US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hA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racellular distribution.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distribution of EphA2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reen) in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2008/SCB, CLDN4KD and CLDN4KD/rescued cells was visualized by </a:t>
            </a:r>
            <a:r>
              <a:rPr lang="en-US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fluorescent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ining using anti-EphA2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body. </a:t>
            </a:r>
            <a:r>
              <a:rPr lang="en-US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lloidin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urple) was used to stain actin.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 fluorescence is from the mCherry-CDLN4. 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8051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284</TotalTime>
  <Words>64</Words>
  <Application>Microsoft Office PowerPoint</Application>
  <PresentationFormat>Custom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well Lab</dc:creator>
  <cp:lastModifiedBy>Howell, Stephen</cp:lastModifiedBy>
  <cp:revision>404</cp:revision>
  <dcterms:created xsi:type="dcterms:W3CDTF">2006-08-16T00:00:00Z</dcterms:created>
  <dcterms:modified xsi:type="dcterms:W3CDTF">2014-08-04T18:19:05Z</dcterms:modified>
</cp:coreProperties>
</file>